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ADFA6-93D0-4296-473B-8B26CCE22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F562B9-2BCA-226F-0761-B78DBDE5F7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C59A4-CDDB-7B25-5808-84CBBB33E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227410-9327-4BE5-04D8-A991AF5A0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1D0CA-9B58-56D0-950F-0C3EB7B21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926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E99BA-87FF-D990-F9ED-CDD356513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D98C7-8B0D-1391-DC4F-41E766D79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B98E20-A49D-1E3D-38BB-307116C1E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6569D-456E-DB9A-6A59-9B12584D6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4AB78-634D-9405-F35C-6CB01AE19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27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E539C3-6B34-6EE6-99FD-EDF0A841E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AC9FB-8BE7-EE9B-FBAB-B769B39A0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F58181-BC65-C3CF-2BF0-C81B56CBF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2A392-1F09-A2D3-3372-1BC28B5EB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FDF5F-024D-E139-37A0-70B0F0AC1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99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E965D-08CA-2B3E-4171-4EEF14024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9CE8D0-AB89-80FE-ADC0-4062777F8B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D2170-0828-8AA5-8405-390B67655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157CD-B5C4-181D-E8D9-B9F1C587F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82335-118A-C20C-728F-8B55CB312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09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0B3EF-7E99-990C-7086-AF4FBDBAD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C96F2-21C7-3659-B791-AE6D37A7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6C2BE-3492-8A3E-5CFE-B0818C53D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4D957-0FB8-4E83-C45F-C1962925F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0F22E-6C7D-2BEC-7B05-60FDB4B73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81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D334B-8EFD-7F9E-7DFE-305A675B5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D32BD-8C77-104D-AD0A-79F1FC1E5B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AB0809-7643-FE81-56D4-4E6E50131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32FEB4-AEAD-3D1F-6721-BEFCF848A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DD6EE-5F47-281E-FB2A-E4DB18EA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80CF53-80C9-D294-69C5-47C9A17A3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257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42FF2-4F1D-DEB2-E04D-0448152D9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360E91-489B-E3F4-2876-E8F784CD7B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18251F-F9E8-6FAF-7A5B-A54C62B5F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0BB8F6-F2C3-4C16-35EF-BF6DE46162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214704-5201-739A-A711-1FFFD61D2D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1B6180-A9D7-BE66-C0B4-B43CD0F8E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F6C3EB-F5CF-AF10-0C7C-0025A7A6A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D74607-2023-AFE5-7F57-595B4C230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204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3A3B5-C942-DB9F-DA1F-416FB8E3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EFD17B-EECB-47E1-5ED6-55EF1077C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E8DC65-D7D8-7693-D51F-0B948D83D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1B26C8-49E8-EBD9-236E-A19884E15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46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FA3147-0A9E-09A0-04F1-87257F579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B959DC-74C0-A386-DA58-6F8A0E26A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67F15C-48B7-75A4-BF8C-844EA3EBB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21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C1BA3-F74E-8C22-1871-6E2B43492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1BCFA1-1562-23A8-7AF3-1D3CF529A8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D6F025-A93A-71BA-6F3E-3A6A32BD5A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CA2F4-951A-B5B1-0275-1B97A0EEB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888B2B-7774-5F7B-7B7E-4435BFBBD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2259ED-8E7A-58BE-D1F9-14DA18288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1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9718D-BBD7-37FD-1BCE-4E1618DAF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FD8D26-81B9-FE47-8F93-022EFF0366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2339DD-0DE5-15E6-43E7-E420763F0E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5A01C2-5D5E-B8AC-7235-975EB82AB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CA7756-C100-1F98-A70F-118FC2DA5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42F0B-BF02-FE9C-7E1B-84A664D76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534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A4D0EB-955E-074B-2C3B-EF1DF370D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9BE625-0D05-A2B1-9441-3D1C41E79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BD88A-E247-5781-D8C3-341849316B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4D028-102C-B5E1-629C-4BF2F6ED93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27D6D0-A848-3999-96D0-16C36FBD0B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612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64E3A-007F-9F98-F7E2-3479D69DEF9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h-TPGS Transferosomes 4h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3F2FAD-2CA4-6B5D-0825-EC1237F5D43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094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05318C-E9B2-2FDE-FB69-428E42CB2500}"/>
              </a:ext>
            </a:extLst>
          </p:cNvPr>
          <p:cNvSpPr txBox="1"/>
          <p:nvPr/>
        </p:nvSpPr>
        <p:spPr>
          <a:xfrm>
            <a:off x="233538" y="1176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4h, 41</a:t>
            </a:r>
          </a:p>
        </p:txBody>
      </p:sp>
      <p:pic>
        <p:nvPicPr>
          <p:cNvPr id="4" name="Picture 3" descr="A picture containing dark&#10;&#10;Description automatically generated">
            <a:extLst>
              <a:ext uri="{FF2B5EF4-FFF2-40B4-BE49-F238E27FC236}">
                <a16:creationId xmlns:a16="http://schemas.microsoft.com/office/drawing/2014/main" id="{2740D609-F726-8273-000B-7E9E692B8E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6062782" y="0"/>
            <a:ext cx="517183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075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E46237-C4F5-5E9E-EE06-36C4C770B7FC}"/>
              </a:ext>
            </a:extLst>
          </p:cNvPr>
          <p:cNvSpPr txBox="1"/>
          <p:nvPr/>
        </p:nvSpPr>
        <p:spPr>
          <a:xfrm>
            <a:off x="0" y="2319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4h, 42</a:t>
            </a:r>
          </a:p>
        </p:txBody>
      </p:sp>
      <p:pic>
        <p:nvPicPr>
          <p:cNvPr id="7" name="Picture 6" descr="Red lights in the dark&#10;&#10;Description automatically generated with low confidence">
            <a:extLst>
              <a:ext uri="{FF2B5EF4-FFF2-40B4-BE49-F238E27FC236}">
                <a16:creationId xmlns:a16="http://schemas.microsoft.com/office/drawing/2014/main" id="{4230CCCE-45B8-A37E-673A-B44064FEE3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244502" y="0"/>
            <a:ext cx="9093895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998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E46237-C4F5-5E9E-EE06-36C4C770B7FC}"/>
              </a:ext>
            </a:extLst>
          </p:cNvPr>
          <p:cNvSpPr txBox="1"/>
          <p:nvPr/>
        </p:nvSpPr>
        <p:spPr>
          <a:xfrm>
            <a:off x="0" y="2319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4h, 43</a:t>
            </a:r>
          </a:p>
        </p:txBody>
      </p:sp>
      <p:pic>
        <p:nvPicPr>
          <p:cNvPr id="4" name="Picture 3" descr="A picture containing dark&#10;&#10;Description automatically generated">
            <a:extLst>
              <a:ext uri="{FF2B5EF4-FFF2-40B4-BE49-F238E27FC236}">
                <a16:creationId xmlns:a16="http://schemas.microsoft.com/office/drawing/2014/main" id="{2819F55B-DDD0-B24E-5527-2635BD8662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9727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92891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E46237-C4F5-5E9E-EE06-36C4C770B7FC}"/>
              </a:ext>
            </a:extLst>
          </p:cNvPr>
          <p:cNvSpPr txBox="1"/>
          <p:nvPr/>
        </p:nvSpPr>
        <p:spPr>
          <a:xfrm>
            <a:off x="0" y="2319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4h, 44</a:t>
            </a:r>
          </a:p>
        </p:txBody>
      </p:sp>
      <p:pic>
        <p:nvPicPr>
          <p:cNvPr id="4" name="Picture 3" descr="A picture containing dark&#10;&#10;Description automatically generated">
            <a:extLst>
              <a:ext uri="{FF2B5EF4-FFF2-40B4-BE49-F238E27FC236}">
                <a16:creationId xmlns:a16="http://schemas.microsoft.com/office/drawing/2014/main" id="{FFA57675-F7EB-DD2A-FBC2-A6FDB00356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2102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00739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E46237-C4F5-5E9E-EE06-36C4C770B7FC}"/>
              </a:ext>
            </a:extLst>
          </p:cNvPr>
          <p:cNvSpPr txBox="1"/>
          <p:nvPr/>
        </p:nvSpPr>
        <p:spPr>
          <a:xfrm>
            <a:off x="0" y="2319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4h, 45</a:t>
            </a:r>
          </a:p>
        </p:txBody>
      </p:sp>
      <p:pic>
        <p:nvPicPr>
          <p:cNvPr id="4" name="Picture 3" descr="A picture containing dark, lit&#10;&#10;Description automatically generated">
            <a:extLst>
              <a:ext uri="{FF2B5EF4-FFF2-40B4-BE49-F238E27FC236}">
                <a16:creationId xmlns:a16="http://schemas.microsoft.com/office/drawing/2014/main" id="{92E5DD51-2008-65B8-41E8-CC8FE0A7F9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581650" y="843081"/>
            <a:ext cx="6857999" cy="5171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9491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8</Words>
  <Application>Microsoft Office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Rh-TPGS Transferosomes 4h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W RH film 4h </dc:title>
  <dc:creator>OSAMAH ABDULHAKIEM ALI AHMAD</dc:creator>
  <cp:lastModifiedBy>OSAMAH ABDULHAKIEM ALI AHMAD</cp:lastModifiedBy>
  <cp:revision>3</cp:revision>
  <dcterms:created xsi:type="dcterms:W3CDTF">2023-05-07T09:06:54Z</dcterms:created>
  <dcterms:modified xsi:type="dcterms:W3CDTF">2023-05-08T16:55:37Z</dcterms:modified>
</cp:coreProperties>
</file>